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57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B9D94-E560-4373-A8F8-2EFB84F855C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BF636-F417-476A-BEA4-3104CBE21110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89057" y="230957"/>
            <a:ext cx="7852527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Times New Roman" panose="02020503050405090304" pitchFamily="18" charset="0"/>
              </a:rPr>
              <a:t> Additional file 1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. Included number, CT value, SUV</a:t>
            </a:r>
            <a:r>
              <a:rPr lang="en-US" sz="1200" baseline="-25000" dirty="0">
                <a:solidFill>
                  <a:srgbClr val="000000"/>
                </a:solidFill>
                <a:latin typeface="Times New Roman" panose="02020503050405090304" pitchFamily="18" charset="0"/>
              </a:rPr>
              <a:t>max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SUV</a:t>
            </a:r>
            <a:r>
              <a:rPr lang="en-US" sz="1200" baseline="-250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mean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 of normal vertebrae in male participants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545997" y="612741"/>
          <a:ext cx="8738648" cy="601430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21342"/>
                <a:gridCol w="793102"/>
                <a:gridCol w="1800216"/>
                <a:gridCol w="903998"/>
                <a:gridCol w="903998"/>
                <a:gridCol w="903998"/>
                <a:gridCol w="903998"/>
                <a:gridCol w="903998"/>
                <a:gridCol w="903998"/>
              </a:tblGrid>
              <a:tr h="216777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Vertebrae</a:t>
                      </a:r>
                      <a:endParaRPr lang="en-US" sz="1000" dirty="0"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Included numb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T values (HU）mean±SD，Co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SUV</a:t>
                      </a:r>
                      <a:r>
                        <a:rPr lang="en-US" sz="1000" u="none" strike="noStrike" baseline="-2500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ma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 hMerge="1">
                  <a:tcPr/>
                </a:tc>
                <a:tc hMerge="1"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SUV</a:t>
                      </a:r>
                      <a:r>
                        <a:rPr lang="en-US" sz="1000" u="none" strike="noStrike" baseline="-2500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me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 hMerge="1">
                  <a:tcPr/>
                </a:tc>
                <a:tc hMerge="1">
                  <a:tcPr/>
                </a:tc>
              </a:tr>
              <a:tr h="226860">
                <a:tc vMerge="1">
                  <a:tcPr/>
                </a:tc>
                <a:tc vMerge="1">
                  <a:tcPr/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(mean±SD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Rang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o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(mean±SD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Rang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o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66±98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46±1.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53-9.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89±0.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34-5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87±77，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16±1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29-11.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41±1.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78-8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60±74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38±1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20-10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9±0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4-7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64±61，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79±1.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55-10.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98±1.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1-8.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75±94，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04±1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5-12.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1±1.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21-7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19±89，0.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16±1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35-10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37±1.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65-8.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72±62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29±2.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07-12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32±1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07-8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33±38，0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41±1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16-12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33±1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5-8.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15±46，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92±1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1-11.9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2±1.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2-7.8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13±47，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96±1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61-10.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19±0.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05-7.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11±38，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72±1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23-11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86±0.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27-7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01±36，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06±1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70-11.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9±0.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1-7.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90±39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84±1.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47-10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0±1.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3-7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80±35，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02±1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20-11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14±1.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8-8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81±37，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17±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74-9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26±1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77-7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75±40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16±1.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81-11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24±1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44-7.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72±38，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04±1.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08-11.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2±0.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9-6.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60±37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82±1.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23-10.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0±0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3-7.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52±40，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96±1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5-10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97±0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9-6.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51±46，0.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98±1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09-11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94±1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48-9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49±40，0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90±1.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88-11.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94±0.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28-7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49±35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57±1.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91-11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9±0.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01-8.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19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57±41，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51±1.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98-10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59±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5-8.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  <a:tr h="2369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64±45，0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8.26±1.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34-16.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.03±0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61-7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647" marR="3647" marT="3647" marB="0" anchor="ctr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08</Words>
  <Application>WPS 文字</Application>
  <PresentationFormat>宽屏</PresentationFormat>
  <Paragraphs>47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7" baseType="lpstr">
      <vt:lpstr>Arial</vt:lpstr>
      <vt:lpstr>方正书宋_GBK</vt:lpstr>
      <vt:lpstr>Wingdings</vt:lpstr>
      <vt:lpstr>Times New Roman</vt:lpstr>
      <vt:lpstr>宋体</vt:lpstr>
      <vt:lpstr>Calibri</vt:lpstr>
      <vt:lpstr>Helvetica Neue</vt:lpstr>
      <vt:lpstr>微软雅黑</vt:lpstr>
      <vt:lpstr>汉仪旗黑KW</vt:lpstr>
      <vt:lpstr>宋体</vt:lpstr>
      <vt:lpstr>Arial Unicode MS</vt:lpstr>
      <vt:lpstr>汉仪书宋二KW</vt:lpstr>
      <vt:lpstr>Calibri Light</vt:lpstr>
      <vt:lpstr>等线</vt:lpstr>
      <vt:lpstr>汉仪中等线KW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e</dc:creator>
  <cp:keywords>C_Unrestricted</cp:keywords>
  <cp:lastModifiedBy>qina</cp:lastModifiedBy>
  <cp:revision>52</cp:revision>
  <dcterms:created xsi:type="dcterms:W3CDTF">2020-12-16T11:31:30Z</dcterms:created>
  <dcterms:modified xsi:type="dcterms:W3CDTF">2020-12-16T11:3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 Confidentiality">
    <vt:lpwstr>Unrestricted</vt:lpwstr>
  </property>
  <property fmtid="{D5CDD505-2E9C-101B-9397-08002B2CF9AE}" pid="3" name="Document_Confidentiality">
    <vt:lpwstr>Unrestricted</vt:lpwstr>
  </property>
  <property fmtid="{D5CDD505-2E9C-101B-9397-08002B2CF9AE}" pid="4" name="sodocoClasLang">
    <vt:lpwstr>Unrestricted</vt:lpwstr>
  </property>
  <property fmtid="{D5CDD505-2E9C-101B-9397-08002B2CF9AE}" pid="5" name="sodocoClasLangId">
    <vt:i4>0</vt:i4>
  </property>
  <property fmtid="{D5CDD505-2E9C-101B-9397-08002B2CF9AE}" pid="6" name="sodocoClasId">
    <vt:i4>0</vt:i4>
  </property>
  <property fmtid="{D5CDD505-2E9C-101B-9397-08002B2CF9AE}" pid="7" name="KSOProductBuildVer">
    <vt:lpwstr>2052-1.5.2.2273</vt:lpwstr>
  </property>
</Properties>
</file>